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49" d="100"/>
          <a:sy n="49" d="100"/>
        </p:scale>
        <p:origin x="58" y="1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8D8959-354A-42F4-BFBC-EB4841B43CE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7C86347-84E3-4B65-99C5-EE56893148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AE7E61-B3DF-4656-94B7-0A7BAF2C4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49527C-EF94-43F8-A4F4-A147BC7EC6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E8CC49-CAA0-46F1-B813-C0C10CC94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8062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A74275-B39A-41EF-93CD-E72B0D110C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228A30-A84C-476D-A2F6-93061F9A1C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181FC7-50CB-4BDB-A7FF-596F76739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A5B48DD-3975-48E9-8C0E-3FB1554A2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1A2E25-4E45-4E07-8A01-82B7378E5F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7072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485AC9-BEB1-4A46-AA26-35D587CD3F7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6AA0B2-951F-48FE-A4C5-4A1123FBFD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1F0639-53E8-450D-B551-486AC68E21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BEB2029-5B22-432E-8C33-6F4CEDFFD8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49ABDA-E284-4B66-AFCA-47AAED01FE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082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1EC204-7C07-4110-8002-911D021260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092145-459D-4F71-A9B1-FF459FFD91F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BBB3AA-97AC-4B74-B999-83A9EA5138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5ED373-7071-42B2-91B4-889BE3C6D3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995001-4150-4A9E-8F41-0F258F644C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3457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6F4B49-BF17-4243-97EA-DEBE982DA2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110E06-2C47-4694-AFA5-4B0FD46FDA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6F380B-B5D2-4A6A-BA79-3D93279D0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03B05-FBB7-4B10-A4A3-A013BC3F7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19AEEB-69AB-440A-A95A-407167D27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978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BA683-6ED1-4973-9729-D8C133B798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082793-FC4D-42CF-BBE0-EEF295A029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4A55A7-6471-4AB8-9DA5-CC8EBA2B0D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302678A-2AF6-4954-BA51-61A82A077F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33751E-F43A-40D6-80A6-0E7DA0CA8E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A55411-A056-4BCF-AA2E-3136C60FD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379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ADA988-B0FE-4005-B16D-AB63F4078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283D7D-7885-45BC-9F13-B29622503F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E69F170-3D93-4612-94AE-A79532AA6B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3C2BFC3-C819-4F73-B3EB-F2116EF55E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91B9DBC-CFBC-46D5-97D8-4E899A4055A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C69D24-6A27-4CFD-8C9B-3154E5BCE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B32B6E-742E-423A-A8B1-FF8CAED68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3006942-9144-4FE3-8216-8105E43D0E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2884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C1C4C-FD8F-45BD-9E6D-D13222515E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5939220-F1D5-4486-8FB7-95419F9A8F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FDE7C3B-6CD4-4A89-9BFB-B55200919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FA650A-30EB-473A-A857-8942734F9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135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705C800-EBF8-432E-A9E5-C334347B74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B126D9B-26D3-40BE-88A0-CEC80402E6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8D6687E-C6FA-41C6-9C1C-E9BC3A7167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79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225C34-532B-4EE8-955A-5DED9011C0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5F6C58-9C38-42AE-B2B4-4D48BE1F43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8776C12-43CD-474A-BECF-63C69ABB53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B23884-DED8-4DAC-B486-54429E93AC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8F1FC4-0E42-4733-A6BD-185EDFECF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5EB4AFE-E404-4184-A00E-6CE8B6BB5F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11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1F289D-455F-4BC3-921E-2C75D1578B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3A9D31-6FE7-410E-9492-4F6FA01EBBA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79451A-0D0F-4851-BE15-13469B0306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9B7B77-60C5-49F7-ADC9-46A6A2F46A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572996-F240-4ACD-B816-F8499A00B3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AE8C0F-964B-417E-B5F7-9467F52282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46642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21909F-AB3C-4757-BE50-AEBED7C409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928A075-A306-4AD8-8983-5A2C767256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55762A-B6BD-49A7-9D4D-FF10A0EF5C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ACD8AC-4106-4BCD-8154-AB5C1EC10F64}" type="datetimeFigureOut">
              <a:rPr lang="en-US" smtClean="0"/>
              <a:t>5/23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0BBE84-409A-4A1D-8023-E3964E7BCFE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EF6D4D-EFBB-4786-90F4-02BFD9A40F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676CE-4113-4EDF-AF9B-349C3853C7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402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3">
            <a:extLst>
              <a:ext uri="{FF2B5EF4-FFF2-40B4-BE49-F238E27FC236}">
                <a16:creationId xmlns:a16="http://schemas.microsoft.com/office/drawing/2014/main" id="{8BE7CFC0-0FD2-42E8-8F04-CE3A59BE80E7}"/>
              </a:ext>
            </a:extLst>
          </p:cNvPr>
          <p:cNvSpPr txBox="1">
            <a:spLocks/>
          </p:cNvSpPr>
          <p:nvPr/>
        </p:nvSpPr>
        <p:spPr>
          <a:xfrm>
            <a:off x="838200" y="457200"/>
            <a:ext cx="105156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ariability in ITS1 and ITS2 sequences of historic (herbaria) and extant (fresh) </a:t>
            </a:r>
            <a:r>
              <a:rPr lang="en-US" sz="2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alaris </a:t>
            </a:r>
            <a:r>
              <a:rPr lang="en-US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es (Graper, Noyszewski, Anderson, Smith) Supplementary </a:t>
            </a:r>
            <a:r>
              <a:rPr lang="en-US" sz="2400">
                <a:latin typeface="Times New Roman" panose="02020603050405020304" pitchFamily="18" charset="0"/>
                <a:cs typeface="Times New Roman" panose="02020603050405020304" pitchFamily="18" charset="0"/>
              </a:rPr>
              <a:t>Figure 2</a:t>
            </a:r>
            <a:endParaRPr lang="en-US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8505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509C643D-0648-496C-9BE9-1201A7F20E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8000" contrast="-27000"/>
                    </a14:imgEffect>
                  </a14:imgLayer>
                </a14:imgProps>
              </a:ext>
            </a:extLst>
          </a:blip>
          <a:srcRect l="-121" t="-39" r="-306" b="-627"/>
          <a:stretch/>
        </p:blipFill>
        <p:spPr>
          <a:xfrm>
            <a:off x="468287" y="1283700"/>
            <a:ext cx="5898996" cy="42906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BC888985-F8D6-4FA2-A6FC-73353707CCB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t="2675"/>
          <a:stretch/>
        </p:blipFill>
        <p:spPr>
          <a:xfrm>
            <a:off x="6556326" y="1283700"/>
            <a:ext cx="2689341" cy="4247938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B8252266-1DDF-4DAC-920F-76BD531BDCA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36000" contrast="-27000"/>
                    </a14:imgEffect>
                  </a14:imgLayer>
                </a14:imgProps>
              </a:ext>
            </a:extLst>
          </a:blip>
          <a:srcRect l="1116" t="508" r="2091" b="597"/>
          <a:stretch/>
        </p:blipFill>
        <p:spPr>
          <a:xfrm>
            <a:off x="9502132" y="1283700"/>
            <a:ext cx="2571917" cy="4247938"/>
          </a:xfrm>
          <a:prstGeom prst="rect">
            <a:avLst/>
          </a:prstGeom>
        </p:spPr>
      </p:pic>
      <p:sp>
        <p:nvSpPr>
          <p:cNvPr id="67" name="TextBox 66">
            <a:extLst>
              <a:ext uri="{FF2B5EF4-FFF2-40B4-BE49-F238E27FC236}">
                <a16:creationId xmlns:a16="http://schemas.microsoft.com/office/drawing/2014/main" id="{0EEF5DDF-539B-48B9-B270-30A7D4E141D8}"/>
              </a:ext>
            </a:extLst>
          </p:cNvPr>
          <p:cNvSpPr txBox="1"/>
          <p:nvPr/>
        </p:nvSpPr>
        <p:spPr>
          <a:xfrm>
            <a:off x="3273918" y="363164"/>
            <a:ext cx="28773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E1E23959-F4E2-4874-AE5F-E31A486B4CA0}"/>
              </a:ext>
            </a:extLst>
          </p:cNvPr>
          <p:cNvSpPr txBox="1"/>
          <p:nvPr/>
        </p:nvSpPr>
        <p:spPr>
          <a:xfrm>
            <a:off x="7501581" y="363164"/>
            <a:ext cx="339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61E6CFF-FCE3-4EF9-BF61-3EE5AE95B583}"/>
              </a:ext>
            </a:extLst>
          </p:cNvPr>
          <p:cNvSpPr txBox="1"/>
          <p:nvPr/>
        </p:nvSpPr>
        <p:spPr>
          <a:xfrm>
            <a:off x="10610561" y="363164"/>
            <a:ext cx="355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graphicFrame>
        <p:nvGraphicFramePr>
          <p:cNvPr id="23" name="Table 36">
            <a:extLst>
              <a:ext uri="{FF2B5EF4-FFF2-40B4-BE49-F238E27FC236}">
                <a16:creationId xmlns:a16="http://schemas.microsoft.com/office/drawing/2014/main" id="{36695908-A5DF-4277-8E35-E88993801F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1455037"/>
              </p:ext>
            </p:extLst>
          </p:nvPr>
        </p:nvGraphicFramePr>
        <p:xfrm>
          <a:off x="528996" y="1002446"/>
          <a:ext cx="5777577" cy="259611"/>
        </p:xfrm>
        <a:graphic>
          <a:graphicData uri="http://schemas.openxmlformats.org/drawingml/2006/table">
            <a:tbl>
              <a:tblPr firstRow="1" bandRow="1"/>
              <a:tblGrid>
                <a:gridCol w="304083">
                  <a:extLst>
                    <a:ext uri="{9D8B030D-6E8A-4147-A177-3AD203B41FA5}">
                      <a16:colId xmlns:a16="http://schemas.microsoft.com/office/drawing/2014/main" val="4268800197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1069748237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868117065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1375255960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1305447527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4058768346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513421484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1032416072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554856125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973113199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1277834440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080564926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2504569133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453854479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134549808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9896234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2145161385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3372713020"/>
                    </a:ext>
                  </a:extLst>
                </a:gridCol>
                <a:gridCol w="304083">
                  <a:extLst>
                    <a:ext uri="{9D8B030D-6E8A-4147-A177-3AD203B41FA5}">
                      <a16:colId xmlns:a16="http://schemas.microsoft.com/office/drawing/2014/main" val="2891970789"/>
                    </a:ext>
                  </a:extLst>
                </a:gridCol>
              </a:tblGrid>
              <a:tr h="259611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509444135"/>
                  </a:ext>
                </a:extLst>
              </a:tr>
            </a:tbl>
          </a:graphicData>
        </a:graphic>
      </p:graphicFrame>
      <p:graphicFrame>
        <p:nvGraphicFramePr>
          <p:cNvPr id="37" name="Table 37">
            <a:extLst>
              <a:ext uri="{FF2B5EF4-FFF2-40B4-BE49-F238E27FC236}">
                <a16:creationId xmlns:a16="http://schemas.microsoft.com/office/drawing/2014/main" id="{967882F9-2FCE-4192-B81B-457317D2E1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4776588"/>
              </p:ext>
            </p:extLst>
          </p:nvPr>
        </p:nvGraphicFramePr>
        <p:xfrm>
          <a:off x="6573246" y="1002445"/>
          <a:ext cx="2672420" cy="264179"/>
        </p:xfrm>
        <a:graphic>
          <a:graphicData uri="http://schemas.openxmlformats.org/drawingml/2006/table">
            <a:tbl>
              <a:tblPr firstRow="1" bandRow="1"/>
              <a:tblGrid>
                <a:gridCol w="267242">
                  <a:extLst>
                    <a:ext uri="{9D8B030D-6E8A-4147-A177-3AD203B41FA5}">
                      <a16:colId xmlns:a16="http://schemas.microsoft.com/office/drawing/2014/main" val="3326309172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2683333876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2795387348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4222997555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4047166359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603522806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1688019222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1456630784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3271781868"/>
                    </a:ext>
                  </a:extLst>
                </a:gridCol>
                <a:gridCol w="267242">
                  <a:extLst>
                    <a:ext uri="{9D8B030D-6E8A-4147-A177-3AD203B41FA5}">
                      <a16:colId xmlns:a16="http://schemas.microsoft.com/office/drawing/2014/main" val="1671783258"/>
                    </a:ext>
                  </a:extLst>
                </a:gridCol>
              </a:tblGrid>
              <a:tr h="26417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78183165"/>
                  </a:ext>
                </a:extLst>
              </a:tr>
            </a:tbl>
          </a:graphicData>
        </a:graphic>
      </p:graphicFrame>
      <p:graphicFrame>
        <p:nvGraphicFramePr>
          <p:cNvPr id="56" name="Table 37">
            <a:extLst>
              <a:ext uri="{FF2B5EF4-FFF2-40B4-BE49-F238E27FC236}">
                <a16:creationId xmlns:a16="http://schemas.microsoft.com/office/drawing/2014/main" id="{B281CCD1-6127-4D63-9EE2-52291F7B3F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32669437"/>
              </p:ext>
            </p:extLst>
          </p:nvPr>
        </p:nvGraphicFramePr>
        <p:xfrm>
          <a:off x="9542836" y="1002445"/>
          <a:ext cx="2271930" cy="264179"/>
        </p:xfrm>
        <a:graphic>
          <a:graphicData uri="http://schemas.openxmlformats.org/drawingml/2006/table">
            <a:tbl>
              <a:tblPr firstRow="1" bandRow="1"/>
              <a:tblGrid>
                <a:gridCol w="227193">
                  <a:extLst>
                    <a:ext uri="{9D8B030D-6E8A-4147-A177-3AD203B41FA5}">
                      <a16:colId xmlns:a16="http://schemas.microsoft.com/office/drawing/2014/main" val="3326309172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2683333876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2795387348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4222997555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4047166359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603522806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1688019222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1456630784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3271781868"/>
                    </a:ext>
                  </a:extLst>
                </a:gridCol>
                <a:gridCol w="227193">
                  <a:extLst>
                    <a:ext uri="{9D8B030D-6E8A-4147-A177-3AD203B41FA5}">
                      <a16:colId xmlns:a16="http://schemas.microsoft.com/office/drawing/2014/main" val="1671783258"/>
                    </a:ext>
                  </a:extLst>
                </a:gridCol>
              </a:tblGrid>
              <a:tr h="264179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6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578183165"/>
                  </a:ext>
                </a:extLst>
              </a:tr>
            </a:tbl>
          </a:graphicData>
        </a:graphic>
      </p:graphicFrame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7BD58F10-1FDD-46B8-9035-1A4DE781AC83}"/>
              </a:ext>
            </a:extLst>
          </p:cNvPr>
          <p:cNvCxnSpPr>
            <a:cxnSpLocks/>
          </p:cNvCxnSpPr>
          <p:nvPr/>
        </p:nvCxnSpPr>
        <p:spPr>
          <a:xfrm>
            <a:off x="6557501" y="3889410"/>
            <a:ext cx="2382444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E8BC081F-0C5F-488D-B357-D4ED0B93DE6D}"/>
              </a:ext>
            </a:extLst>
          </p:cNvPr>
          <p:cNvCxnSpPr>
            <a:cxnSpLocks/>
          </p:cNvCxnSpPr>
          <p:nvPr/>
        </p:nvCxnSpPr>
        <p:spPr>
          <a:xfrm>
            <a:off x="6570220" y="1524591"/>
            <a:ext cx="2382444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DFF3D06E-EEA0-4411-B85E-F50390D35DCD}"/>
              </a:ext>
            </a:extLst>
          </p:cNvPr>
          <p:cNvCxnSpPr>
            <a:cxnSpLocks/>
          </p:cNvCxnSpPr>
          <p:nvPr/>
        </p:nvCxnSpPr>
        <p:spPr>
          <a:xfrm flipH="1">
            <a:off x="8937054" y="1524590"/>
            <a:ext cx="6992" cy="2381897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A1E95D6A-F74B-4988-8B62-67D4DC9E75C3}"/>
              </a:ext>
            </a:extLst>
          </p:cNvPr>
          <p:cNvCxnSpPr>
            <a:cxnSpLocks/>
          </p:cNvCxnSpPr>
          <p:nvPr/>
        </p:nvCxnSpPr>
        <p:spPr>
          <a:xfrm>
            <a:off x="6570220" y="1516053"/>
            <a:ext cx="0" cy="2402417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12397F58-7CC8-4D08-81A7-EB7775449095}"/>
              </a:ext>
            </a:extLst>
          </p:cNvPr>
          <p:cNvCxnSpPr>
            <a:cxnSpLocks/>
          </p:cNvCxnSpPr>
          <p:nvPr/>
        </p:nvCxnSpPr>
        <p:spPr>
          <a:xfrm>
            <a:off x="568123" y="1782928"/>
            <a:ext cx="584694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C6FD7375-DA3F-4843-AC4D-260F62406F01}"/>
              </a:ext>
            </a:extLst>
          </p:cNvPr>
          <p:cNvCxnSpPr>
            <a:cxnSpLocks/>
          </p:cNvCxnSpPr>
          <p:nvPr/>
        </p:nvCxnSpPr>
        <p:spPr>
          <a:xfrm>
            <a:off x="578327" y="3562991"/>
            <a:ext cx="584694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E2CBE1D8-1AE4-4800-9267-9BAB622650E6}"/>
              </a:ext>
            </a:extLst>
          </p:cNvPr>
          <p:cNvCxnSpPr>
            <a:cxnSpLocks/>
          </p:cNvCxnSpPr>
          <p:nvPr/>
        </p:nvCxnSpPr>
        <p:spPr>
          <a:xfrm flipH="1" flipV="1">
            <a:off x="1152817" y="1782928"/>
            <a:ext cx="10204" cy="1780063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925BC834-12E5-49C1-AF2A-371DE2842B24}"/>
              </a:ext>
            </a:extLst>
          </p:cNvPr>
          <p:cNvCxnSpPr>
            <a:cxnSpLocks/>
          </p:cNvCxnSpPr>
          <p:nvPr/>
        </p:nvCxnSpPr>
        <p:spPr>
          <a:xfrm flipH="1" flipV="1">
            <a:off x="574226" y="1772106"/>
            <a:ext cx="10204" cy="1780063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605B740A-0221-48BB-ADD2-2173CB61BC82}"/>
              </a:ext>
            </a:extLst>
          </p:cNvPr>
          <p:cNvCxnSpPr>
            <a:cxnSpLocks/>
          </p:cNvCxnSpPr>
          <p:nvPr/>
        </p:nvCxnSpPr>
        <p:spPr>
          <a:xfrm>
            <a:off x="1468510" y="1792229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E4B91ACF-6AE6-420A-9D7A-ED2AC2E7DF9C}"/>
              </a:ext>
            </a:extLst>
          </p:cNvPr>
          <p:cNvCxnSpPr>
            <a:cxnSpLocks/>
          </p:cNvCxnSpPr>
          <p:nvPr/>
        </p:nvCxnSpPr>
        <p:spPr>
          <a:xfrm>
            <a:off x="1468510" y="3575811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11D2F439-DAAF-4023-A334-BE5DF5DE06AF}"/>
              </a:ext>
            </a:extLst>
          </p:cNvPr>
          <p:cNvCxnSpPr>
            <a:cxnSpLocks/>
          </p:cNvCxnSpPr>
          <p:nvPr/>
        </p:nvCxnSpPr>
        <p:spPr>
          <a:xfrm>
            <a:off x="1767846" y="1792229"/>
            <a:ext cx="0" cy="1783582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D909371A-D624-487A-9B57-7D76CFF52840}"/>
              </a:ext>
            </a:extLst>
          </p:cNvPr>
          <p:cNvCxnSpPr>
            <a:cxnSpLocks/>
          </p:cNvCxnSpPr>
          <p:nvPr/>
        </p:nvCxnSpPr>
        <p:spPr>
          <a:xfrm>
            <a:off x="1480443" y="1823747"/>
            <a:ext cx="0" cy="1783582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2ACE6CC0-A058-427B-90B8-F858AFF9C959}"/>
              </a:ext>
            </a:extLst>
          </p:cNvPr>
          <p:cNvCxnSpPr>
            <a:cxnSpLocks/>
          </p:cNvCxnSpPr>
          <p:nvPr/>
        </p:nvCxnSpPr>
        <p:spPr>
          <a:xfrm>
            <a:off x="2660964" y="1772106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C7D39FF6-881A-40E0-87B9-C787FB019C54}"/>
              </a:ext>
            </a:extLst>
          </p:cNvPr>
          <p:cNvCxnSpPr>
            <a:cxnSpLocks/>
          </p:cNvCxnSpPr>
          <p:nvPr/>
        </p:nvCxnSpPr>
        <p:spPr>
          <a:xfrm>
            <a:off x="2660964" y="3580749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84673B71-964B-4D1B-9997-6B16F258A33C}"/>
              </a:ext>
            </a:extLst>
          </p:cNvPr>
          <p:cNvCxnSpPr>
            <a:cxnSpLocks/>
          </p:cNvCxnSpPr>
          <p:nvPr/>
        </p:nvCxnSpPr>
        <p:spPr>
          <a:xfrm>
            <a:off x="2674932" y="1782928"/>
            <a:ext cx="0" cy="1780063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25188911-FFCB-4C2D-9A61-342D48653015}"/>
              </a:ext>
            </a:extLst>
          </p:cNvPr>
          <p:cNvCxnSpPr>
            <a:cxnSpLocks/>
          </p:cNvCxnSpPr>
          <p:nvPr/>
        </p:nvCxnSpPr>
        <p:spPr>
          <a:xfrm>
            <a:off x="2960300" y="1772106"/>
            <a:ext cx="0" cy="1780063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53659977-B14B-45F8-913F-7F4290D8B5DA}"/>
              </a:ext>
            </a:extLst>
          </p:cNvPr>
          <p:cNvCxnSpPr>
            <a:cxnSpLocks/>
          </p:cNvCxnSpPr>
          <p:nvPr/>
        </p:nvCxnSpPr>
        <p:spPr>
          <a:xfrm>
            <a:off x="3292270" y="1769763"/>
            <a:ext cx="0" cy="180604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A3644099-287E-4E24-8203-9F538817577A}"/>
              </a:ext>
            </a:extLst>
          </p:cNvPr>
          <p:cNvCxnSpPr>
            <a:cxnSpLocks/>
          </p:cNvCxnSpPr>
          <p:nvPr/>
        </p:nvCxnSpPr>
        <p:spPr>
          <a:xfrm>
            <a:off x="2992934" y="1772106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2FA9B617-C9B9-460A-B13E-E07A64FF3757}"/>
              </a:ext>
            </a:extLst>
          </p:cNvPr>
          <p:cNvCxnSpPr>
            <a:cxnSpLocks/>
          </p:cNvCxnSpPr>
          <p:nvPr/>
        </p:nvCxnSpPr>
        <p:spPr>
          <a:xfrm>
            <a:off x="2992934" y="3575811"/>
            <a:ext cx="29933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Connector 95">
            <a:extLst>
              <a:ext uri="{FF2B5EF4-FFF2-40B4-BE49-F238E27FC236}">
                <a16:creationId xmlns:a16="http://schemas.microsoft.com/office/drawing/2014/main" id="{8A8489B1-5D2B-49E9-BC57-5ECCBF1B890A}"/>
              </a:ext>
            </a:extLst>
          </p:cNvPr>
          <p:cNvCxnSpPr>
            <a:cxnSpLocks/>
          </p:cNvCxnSpPr>
          <p:nvPr/>
        </p:nvCxnSpPr>
        <p:spPr>
          <a:xfrm flipH="1">
            <a:off x="9506117" y="2098215"/>
            <a:ext cx="508650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AB59FA8C-7827-4D39-8EF2-A5BBFAC5FBF2}"/>
              </a:ext>
            </a:extLst>
          </p:cNvPr>
          <p:cNvCxnSpPr>
            <a:cxnSpLocks/>
          </p:cNvCxnSpPr>
          <p:nvPr/>
        </p:nvCxnSpPr>
        <p:spPr>
          <a:xfrm flipH="1">
            <a:off x="9495166" y="4855862"/>
            <a:ext cx="508650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12EB4E55-290B-4F71-8DC1-1F5A60F721B0}"/>
              </a:ext>
            </a:extLst>
          </p:cNvPr>
          <p:cNvCxnSpPr>
            <a:cxnSpLocks/>
          </p:cNvCxnSpPr>
          <p:nvPr/>
        </p:nvCxnSpPr>
        <p:spPr>
          <a:xfrm flipH="1">
            <a:off x="10001170" y="2098215"/>
            <a:ext cx="13597" cy="2757647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5B3050D1-16C1-4BA0-9178-BCC8102A3BD1}"/>
              </a:ext>
            </a:extLst>
          </p:cNvPr>
          <p:cNvCxnSpPr>
            <a:cxnSpLocks/>
          </p:cNvCxnSpPr>
          <p:nvPr/>
        </p:nvCxnSpPr>
        <p:spPr>
          <a:xfrm flipH="1">
            <a:off x="9517068" y="2098214"/>
            <a:ext cx="6799" cy="2774724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644EAFD3-6C5A-469A-8FD8-0130E664BF5D}"/>
              </a:ext>
            </a:extLst>
          </p:cNvPr>
          <p:cNvCxnSpPr>
            <a:cxnSpLocks/>
          </p:cNvCxnSpPr>
          <p:nvPr/>
        </p:nvCxnSpPr>
        <p:spPr>
          <a:xfrm flipH="1">
            <a:off x="11367322" y="2120513"/>
            <a:ext cx="20960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CB86C456-DCD5-4F71-9110-9EEE75DE0965}"/>
              </a:ext>
            </a:extLst>
          </p:cNvPr>
          <p:cNvCxnSpPr>
            <a:cxnSpLocks/>
          </p:cNvCxnSpPr>
          <p:nvPr/>
        </p:nvCxnSpPr>
        <p:spPr>
          <a:xfrm flipH="1">
            <a:off x="11385108" y="4862664"/>
            <a:ext cx="209606" cy="0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F20C769D-95FA-46C5-A36A-3631ED7403D4}"/>
              </a:ext>
            </a:extLst>
          </p:cNvPr>
          <p:cNvCxnSpPr>
            <a:cxnSpLocks/>
          </p:cNvCxnSpPr>
          <p:nvPr/>
        </p:nvCxnSpPr>
        <p:spPr>
          <a:xfrm flipH="1" flipV="1">
            <a:off x="11357267" y="2120514"/>
            <a:ext cx="10055" cy="273534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1BE8A8EB-D329-46CA-A047-853AC5773A47}"/>
              </a:ext>
            </a:extLst>
          </p:cNvPr>
          <p:cNvCxnSpPr>
            <a:cxnSpLocks/>
          </p:cNvCxnSpPr>
          <p:nvPr/>
        </p:nvCxnSpPr>
        <p:spPr>
          <a:xfrm flipH="1" flipV="1">
            <a:off x="11600800" y="2098214"/>
            <a:ext cx="10055" cy="2735348"/>
          </a:xfrm>
          <a:prstGeom prst="line">
            <a:avLst/>
          </a:prstGeom>
          <a:ln w="12700">
            <a:solidFill>
              <a:schemeClr val="bg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C8429E62-004E-4845-A211-08A239212CDB}"/>
              </a:ext>
            </a:extLst>
          </p:cNvPr>
          <p:cNvSpPr txBox="1"/>
          <p:nvPr/>
        </p:nvSpPr>
        <p:spPr>
          <a:xfrm>
            <a:off x="-31243" y="2542714"/>
            <a:ext cx="4677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42F54F6-C599-4DD3-ADCD-DADC285127FE}"/>
              </a:ext>
            </a:extLst>
          </p:cNvPr>
          <p:cNvSpPr txBox="1"/>
          <p:nvPr/>
        </p:nvSpPr>
        <p:spPr>
          <a:xfrm>
            <a:off x="-79304" y="2768615"/>
            <a:ext cx="7975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00 </a:t>
            </a:r>
            <a:r>
              <a:rPr lang="en-US" sz="8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endParaRPr lang="en-US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13" name="Straight Arrow Connector 112">
            <a:extLst>
              <a:ext uri="{FF2B5EF4-FFF2-40B4-BE49-F238E27FC236}">
                <a16:creationId xmlns:a16="http://schemas.microsoft.com/office/drawing/2014/main" id="{7827C568-E651-44FA-AF8A-CB3F98197E79}"/>
              </a:ext>
            </a:extLst>
          </p:cNvPr>
          <p:cNvCxnSpPr/>
          <p:nvPr/>
        </p:nvCxnSpPr>
        <p:spPr>
          <a:xfrm flipV="1">
            <a:off x="290552" y="2672787"/>
            <a:ext cx="1828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>
            <a:extLst>
              <a:ext uri="{FF2B5EF4-FFF2-40B4-BE49-F238E27FC236}">
                <a16:creationId xmlns:a16="http://schemas.microsoft.com/office/drawing/2014/main" id="{BC8FE04E-38F5-481D-8BD4-783C15292815}"/>
              </a:ext>
            </a:extLst>
          </p:cNvPr>
          <p:cNvCxnSpPr/>
          <p:nvPr/>
        </p:nvCxnSpPr>
        <p:spPr>
          <a:xfrm flipV="1">
            <a:off x="285407" y="2885743"/>
            <a:ext cx="18288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072345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76</Words>
  <Application>Microsoft Office PowerPoint</Application>
  <PresentationFormat>Widescreen</PresentationFormat>
  <Paragraphs>4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Graper</dc:creator>
  <cp:lastModifiedBy>Alli Graper</cp:lastModifiedBy>
  <cp:revision>6</cp:revision>
  <dcterms:created xsi:type="dcterms:W3CDTF">2021-01-22T20:43:25Z</dcterms:created>
  <dcterms:modified xsi:type="dcterms:W3CDTF">2021-05-24T04:24:30Z</dcterms:modified>
</cp:coreProperties>
</file>